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00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748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074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1461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388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212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3968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67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050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3923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140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0063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3FC12-8A54-427E-84CA-BD3D9A71A63C}" type="datetimeFigureOut">
              <a:rPr kumimoji="1" lang="ja-JP" altLang="en-US" smtClean="0"/>
              <a:t>2015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680A67-5BC9-41BF-B351-7A29A676BA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845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8654628"/>
              </p:ext>
            </p:extLst>
          </p:nvPr>
        </p:nvGraphicFramePr>
        <p:xfrm>
          <a:off x="683568" y="764704"/>
          <a:ext cx="7807837" cy="4975512"/>
        </p:xfrm>
        <a:graphic>
          <a:graphicData uri="http://schemas.openxmlformats.org/drawingml/2006/table">
            <a:tbl>
              <a:tblPr/>
              <a:tblGrid>
                <a:gridCol w="1944979"/>
                <a:gridCol w="977143"/>
                <a:gridCol w="977143"/>
                <a:gridCol w="977143"/>
                <a:gridCol w="977143"/>
                <a:gridCol w="977143"/>
                <a:gridCol w="977143"/>
              </a:tblGrid>
              <a:tr h="362326">
                <a:tc rowSpan="2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ja-JP" alt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　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SU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BG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l-GR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α-</a:t>
                      </a: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GI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TZD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Glinide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DPP-4 inhibitor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6232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629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130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592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351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223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sz="11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N=995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 gridSpan="7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ctr"/>
                      <a:r>
                        <a:rPr kumimoji="1" lang="en-GB" altLang="ja-JP" sz="1200" b="1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Use of antihypertensive drugs</a:t>
                      </a:r>
                      <a:endParaRPr lang="en-US" sz="9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endParaRPr lang="en-US" altLang="ja-JP" sz="1100" b="0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ARB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6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1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6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2.9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61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4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6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8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5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2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0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0.2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>
                      <a:lvl1pPr marL="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1pPr>
                      <a:lvl2pPr marL="457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2pPr>
                      <a:lvl3pPr marL="914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3pPr>
                      <a:lvl4pPr marL="1371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4pPr>
                      <a:lvl5pPr marL="18288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5pPr>
                      <a:lvl6pPr marL="22860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6pPr>
                      <a:lvl7pPr marL="27432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7pPr>
                      <a:lvl8pPr marL="32004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8pPr>
                      <a:lvl9pPr marL="3657600" algn="l" defTabSz="914400" rtl="0" eaLnBrk="1" latinLnBrk="0" hangingPunct="1">
                        <a:defRPr kumimoji="1" sz="1800" kern="1200">
                          <a:solidFill>
                            <a:schemeClr val="tx1"/>
                          </a:solidFill>
                          <a:latin typeface="Calibri"/>
                        </a:defRPr>
                      </a:lvl9pPr>
                    </a:lstStyle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CCB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8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4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7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36.0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46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1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5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38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0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5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36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kumimoji="1" lang="en-US" sz="11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ACE-I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7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1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8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9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.8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1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9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7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.7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Diuretic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0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6.2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2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9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6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6.2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9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6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20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7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3.8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l-GR" altLang="ja-JP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Β</a:t>
                      </a:r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-blocker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21.0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5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1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35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22.8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6.8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8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7.0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85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8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kumimoji="1" lang="en-US" altLang="ja-JP" sz="1100" b="1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Other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.8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2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.0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1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6.9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8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5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3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0.3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4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.4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 gridSpan="7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Use of lipid lowering drug</a:t>
                      </a: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n-US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Statin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297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7.2)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648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9.6)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18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53.7)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96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55.8)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92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41.3)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17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52.0)</a:t>
                      </a:r>
                      <a:endParaRPr kumimoji="1" lang="en-US" altLang="ja-JP" sz="1100" b="0" i="0" u="none" strike="noStrike" kern="1200" dirty="0" smtClean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+mn-cs"/>
                      </a:endParaRP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425086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</a:rPr>
                        <a:t>Other</a:t>
                      </a:r>
                      <a:endParaRPr lang="en-US" sz="1100" b="1" i="0" u="none" strike="noStrike" dirty="0">
                        <a:solidFill>
                          <a:schemeClr val="tx1"/>
                        </a:solidFill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</a:endParaRPr>
                    </a:p>
                  </a:txBody>
                  <a:tcPr marL="7161" marR="7161" marT="7161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0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6.5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99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5.2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16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9.6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56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6.0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34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5.2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170</a:t>
                      </a:r>
                    </a:p>
                    <a:p>
                      <a:pPr marL="0" algn="ctr" defTabSz="914400" rtl="0" eaLnBrk="1" fontAlgn="ctr" latinLnBrk="0" hangingPunct="1"/>
                      <a:r>
                        <a:rPr kumimoji="1" lang="en-US" altLang="ja-JP" sz="11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+mn-cs"/>
                        </a:rPr>
                        <a:t>(17.1)</a:t>
                      </a:r>
                    </a:p>
                  </a:txBody>
                  <a:tcPr marL="9525" marR="9525" marT="9525" marB="0" anchor="ctr">
                    <a:lnL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714161" y="5903694"/>
            <a:ext cx="81063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altLang="ja-JP" sz="1100" dirty="0" smtClean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ta </a:t>
            </a:r>
            <a:r>
              <a:rPr lang="en-GB" altLang="ja-JP" sz="110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re n </a:t>
            </a:r>
            <a:r>
              <a:rPr lang="en-GB" altLang="ja-JP" sz="110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%)</a:t>
            </a:r>
            <a:endParaRPr lang="ja-JP" altLang="en-US" sz="1100" dirty="0">
              <a:solidFill>
                <a:prstClr val="black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308304" y="128489"/>
            <a:ext cx="1704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/>
              <a:t>Additional file</a:t>
            </a:r>
            <a:r>
              <a:rPr kumimoji="1" lang="en-US" altLang="ja-JP" b="1" dirty="0" smtClean="0"/>
              <a:t> </a:t>
            </a:r>
            <a:r>
              <a:rPr kumimoji="1" lang="en-US" altLang="ja-JP" b="1" dirty="0" smtClean="0"/>
              <a:t>1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3618488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31</Words>
  <Application>Microsoft Office PowerPoint</Application>
  <PresentationFormat>画面に合わせる (4:3)</PresentationFormat>
  <Paragraphs>12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邉真紀人</dc:creator>
  <cp:lastModifiedBy>田邉真紀人</cp:lastModifiedBy>
  <cp:revision>1</cp:revision>
  <dcterms:created xsi:type="dcterms:W3CDTF">2015-07-31T17:01:32Z</dcterms:created>
  <dcterms:modified xsi:type="dcterms:W3CDTF">2015-07-31T17:09:27Z</dcterms:modified>
</cp:coreProperties>
</file>